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CE784-0392-402C-AC62-4ED77BBDE0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01A52D-C54D-4842-9F33-BFFF203855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6FBD3F-FAB1-4704-8CA4-702F4D296A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B643E1-0126-4261-A4DC-4FA2BE71F9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8C7CE-14D0-4719-A8D1-043FF84BF5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0D2D82-C4C9-4A35-9324-A919C1438F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98C3CF-376B-4184-8B02-11CC1AA647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5B07C-C3F2-4DFA-B897-12216BC587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A62CB0-2D80-4F14-81D7-7DC4938302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41278-102E-4960-8C81-7BD577FDA9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5C0895-19FA-4A18-BFFA-7E52DE2784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B6F541-8039-411F-95D3-2EF9376912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849232-D462-4A14-8731-02A43D238F0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dentification of candidate regions in the timing QTLs by combined genetic and molecular map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2171880" y="2335320"/>
            <a:ext cx="4800600" cy="22176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T S Kaiser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 Nature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1–5 (2016) doi:10.1038/nature2015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1-16T11:18:52Z</dcterms:created>
  <dc:creator>ravikumar.n</dc:creator>
  <dc:description/>
  <dc:language>en-US</dc:language>
  <cp:lastModifiedBy>ravikumar.n</cp:lastModifiedBy>
  <dcterms:modified xsi:type="dcterms:W3CDTF">2016-11-16T11:18:55Z</dcterms:modified>
  <cp:revision>1</cp:revision>
  <dc:subject/>
  <dc:title>Identification of candidate regions in the timing QTLs by combined genetic and molecular maps</dc:title>
</cp:coreProperties>
</file>